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0" r:id="rId3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2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9" autoAdjust="0"/>
    <p:restoredTop sz="94660"/>
  </p:normalViewPr>
  <p:slideViewPr>
    <p:cSldViewPr snapToGrid="0" showGuides="1">
      <p:cViewPr varScale="1">
        <p:scale>
          <a:sx n="118" d="100"/>
          <a:sy n="118" d="100"/>
        </p:scale>
        <p:origin x="1092" y="84"/>
      </p:cViewPr>
      <p:guideLst>
        <p:guide orient="horz" pos="2024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3024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30110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7376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235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2707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407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75354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372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408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234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4395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97A74A-7679-4AEB-9059-594901086DDC}" type="datetimeFigureOut">
              <a:rPr lang="en-US" smtClean="0"/>
              <a:t>1/2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49C0DD-F7BD-46E7-B02F-ABC971A451A2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4229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1226916" y="8380071"/>
            <a:ext cx="44666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ceiver Operating Characteristic (ROC) curve</a:t>
            </a:r>
            <a:endParaRPr lang="en-US" dirty="0"/>
          </a:p>
        </p:txBody>
      </p:sp>
      <p:sp>
        <p:nvSpPr>
          <p:cNvPr id="15" name="ZoneTexte 14"/>
          <p:cNvSpPr txBox="1"/>
          <p:nvPr/>
        </p:nvSpPr>
        <p:spPr>
          <a:xfrm>
            <a:off x="384434" y="6005310"/>
            <a:ext cx="153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 S1</a:t>
            </a:r>
            <a:endParaRPr lang="en-US" sz="1200" b="1" dirty="0"/>
          </a:p>
        </p:txBody>
      </p:sp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2"/>
          <a:srcRect l="15061" t="27874" r="25407" b="5549"/>
          <a:stretch/>
        </p:blipFill>
        <p:spPr>
          <a:xfrm>
            <a:off x="7267904" y="2971801"/>
            <a:ext cx="819807" cy="851338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/>
          <a:srcRect t="18215" r="17317"/>
          <a:stretch/>
        </p:blipFill>
        <p:spPr>
          <a:xfrm>
            <a:off x="1592318" y="1474077"/>
            <a:ext cx="5194738" cy="3764391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 rot="16200000">
            <a:off x="646387" y="3101454"/>
            <a:ext cx="153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Cycle Threshold (Ct)</a:t>
            </a:r>
            <a:endParaRPr lang="en-US" sz="12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3772388" y="5284977"/>
            <a:ext cx="153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Dilutions (Log)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798280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583150" y="4400488"/>
            <a:ext cx="19656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pecificity (False positive rate)</a:t>
            </a:r>
            <a:endParaRPr lang="en-US" sz="1100" b="1" dirty="0"/>
          </a:p>
        </p:txBody>
      </p:sp>
      <p:sp>
        <p:nvSpPr>
          <p:cNvPr id="6" name="ZoneTexte 5"/>
          <p:cNvSpPr txBox="1"/>
          <p:nvPr/>
        </p:nvSpPr>
        <p:spPr>
          <a:xfrm rot="16200000">
            <a:off x="-533879" y="3555261"/>
            <a:ext cx="19463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Sensitivity (True positive rate)</a:t>
            </a:r>
            <a:endParaRPr lang="en-US" sz="11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1226916" y="8380071"/>
            <a:ext cx="44666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Receiver Operating Characteristic (ROC) curve</a:t>
            </a:r>
            <a:endParaRPr lang="en-US" dirty="0"/>
          </a:p>
        </p:txBody>
      </p:sp>
      <p:cxnSp>
        <p:nvCxnSpPr>
          <p:cNvPr id="12" name="Connecteur droit avec flèche 11"/>
          <p:cNvCxnSpPr/>
          <p:nvPr/>
        </p:nvCxnSpPr>
        <p:spPr>
          <a:xfrm flipV="1">
            <a:off x="587173" y="4131240"/>
            <a:ext cx="0" cy="409302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/>
          <p:nvPr/>
        </p:nvCxnSpPr>
        <p:spPr>
          <a:xfrm>
            <a:off x="678613" y="4414267"/>
            <a:ext cx="526869" cy="435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ZoneTexte 14"/>
          <p:cNvSpPr txBox="1"/>
          <p:nvPr/>
        </p:nvSpPr>
        <p:spPr>
          <a:xfrm>
            <a:off x="1367245" y="5329646"/>
            <a:ext cx="153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 S2</a:t>
            </a:r>
            <a:endParaRPr lang="en-US" sz="1200" b="1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2"/>
          <a:srcRect l="30354" t="30688" r="25487" b="1347"/>
          <a:stretch/>
        </p:blipFill>
        <p:spPr>
          <a:xfrm>
            <a:off x="5971922" y="2133200"/>
            <a:ext cx="2476162" cy="21436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Image 13"/>
          <p:cNvPicPr>
            <a:picLocks noChangeAspect="1"/>
          </p:cNvPicPr>
          <p:nvPr/>
        </p:nvPicPr>
        <p:blipFill rotWithShape="1">
          <a:blip r:embed="rId3"/>
          <a:srcRect l="31416" t="20777" r="23982" b="12360"/>
          <a:stretch/>
        </p:blipFill>
        <p:spPr>
          <a:xfrm>
            <a:off x="695914" y="2175121"/>
            <a:ext cx="2500973" cy="21089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4"/>
          <a:srcRect l="30265" t="25025" r="25575" b="7955"/>
          <a:stretch/>
        </p:blipFill>
        <p:spPr>
          <a:xfrm>
            <a:off x="3333918" y="2156140"/>
            <a:ext cx="2476163" cy="21139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ZoneTexte 2"/>
          <p:cNvSpPr txBox="1"/>
          <p:nvPr/>
        </p:nvSpPr>
        <p:spPr>
          <a:xfrm>
            <a:off x="2399838" y="3854880"/>
            <a:ext cx="6126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GAPDH</a:t>
            </a:r>
            <a:endParaRPr lang="en-US" sz="11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5004618" y="3870313"/>
            <a:ext cx="5469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RPLP0</a:t>
            </a:r>
            <a:endParaRPr lang="en-US" sz="1100" b="1" dirty="0"/>
          </a:p>
        </p:txBody>
      </p:sp>
      <p:sp>
        <p:nvSpPr>
          <p:cNvPr id="4" name="ZoneTexte 3"/>
          <p:cNvSpPr txBox="1"/>
          <p:nvPr/>
        </p:nvSpPr>
        <p:spPr>
          <a:xfrm>
            <a:off x="7104508" y="3853938"/>
            <a:ext cx="113845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 smtClean="0"/>
              <a:t>GAPDH &amp; RPLP0</a:t>
            </a:r>
            <a:endParaRPr 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36200783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5</TotalTime>
  <Words>44</Words>
  <Application>Microsoft Office PowerPoint</Application>
  <PresentationFormat>Affichage à l'écran (4:3)</PresentationFormat>
  <Paragraphs>11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ristophe FERRAND</dc:creator>
  <cp:lastModifiedBy>Christophe FERRAND</cp:lastModifiedBy>
  <cp:revision>13</cp:revision>
  <dcterms:created xsi:type="dcterms:W3CDTF">2016-11-14T14:12:25Z</dcterms:created>
  <dcterms:modified xsi:type="dcterms:W3CDTF">2018-01-20T16:05:42Z</dcterms:modified>
</cp:coreProperties>
</file>